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195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902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8438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4243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8337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130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2740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009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9900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465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8665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DC725-BDBF-43A1-A7C5-A8B36616C40B}" type="datetimeFigureOut">
              <a:rPr lang="zh-CN" altLang="en-US" smtClean="0"/>
              <a:t>2021/4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BC697-6CEE-4EC6-A0B1-C3A292FDF8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2585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/>
          <p:nvPr/>
        </p:nvGrpSpPr>
        <p:grpSpPr>
          <a:xfrm>
            <a:off x="2430920" y="995014"/>
            <a:ext cx="6831417" cy="2469619"/>
            <a:chOff x="2338323" y="2731216"/>
            <a:chExt cx="6831417" cy="246961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56" t="48159" r="31621" b="34807"/>
            <a:stretch/>
          </p:blipFill>
          <p:spPr>
            <a:xfrm>
              <a:off x="3087584" y="3123210"/>
              <a:ext cx="6080167" cy="1961834"/>
            </a:xfrm>
            <a:prstGeom prst="rect">
              <a:avLst/>
            </a:prstGeom>
          </p:spPr>
        </p:pic>
        <p:cxnSp>
          <p:nvCxnSpPr>
            <p:cNvPr id="8" name="直接连接符 7"/>
            <p:cNvCxnSpPr/>
            <p:nvPr/>
          </p:nvCxnSpPr>
          <p:spPr>
            <a:xfrm>
              <a:off x="3622876" y="3055716"/>
              <a:ext cx="125006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接连接符 8"/>
            <p:cNvCxnSpPr/>
            <p:nvPr/>
          </p:nvCxnSpPr>
          <p:spPr>
            <a:xfrm>
              <a:off x="4967468" y="3055716"/>
              <a:ext cx="125006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6358360" y="3055716"/>
              <a:ext cx="125006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7737676" y="3055716"/>
              <a:ext cx="125006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3763804" y="2731216"/>
              <a:ext cx="13228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- </a:t>
              </a:r>
              <a:r>
                <a:rPr lang="en-US" altLang="zh-CN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Jurkat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009296" y="2731216"/>
              <a:ext cx="1467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C - </a:t>
              </a:r>
              <a:r>
                <a:rPr lang="en-US" altLang="zh-CN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Jurkat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408934" y="2731216"/>
              <a:ext cx="1340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- HCT116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7701926" y="2731216"/>
              <a:ext cx="1467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C - HCT116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2506492" y="3169510"/>
              <a:ext cx="625449" cy="2031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</a:p>
            <a:p>
              <a:pPr algn="r"/>
              <a:endParaRPr lang="en-US" altLang="zh-CN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</a:p>
            <a:p>
              <a:pPr algn="r"/>
              <a:endPara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</a:p>
            <a:p>
              <a:pPr algn="r"/>
              <a:endPara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  <a:p>
              <a:pPr algn="r"/>
              <a:endParaRPr lang="en-US" altLang="zh-CN" sz="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  <a:p>
              <a:pPr algn="r"/>
              <a:endPara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  <a:p>
              <a:pPr algn="r"/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338323" y="2810827"/>
              <a:ext cx="8454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(bp)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文本框 20"/>
          <p:cNvSpPr txBox="1"/>
          <p:nvPr/>
        </p:nvSpPr>
        <p:spPr>
          <a:xfrm>
            <a:off x="1520942" y="3569512"/>
            <a:ext cx="93986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P4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products for bisulfite Sanger sequencing amplified by paired degenerate primers from converted (C) and unconverted (UC) genomic DNA were run on 2% agarose gel. M, DNA molecular weight marker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8333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/>
          <p:cNvGrpSpPr/>
          <p:nvPr/>
        </p:nvGrpSpPr>
        <p:grpSpPr>
          <a:xfrm>
            <a:off x="648183" y="1434788"/>
            <a:ext cx="10094032" cy="1629825"/>
            <a:chOff x="266218" y="1677856"/>
            <a:chExt cx="10094032" cy="1629825"/>
          </a:xfrm>
        </p:grpSpPr>
        <p:pic>
          <p:nvPicPr>
            <p:cNvPr id="4" name="图片 3" descr="C:\Users\zgd\AppData\Local\Temp\1607903881(1).png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3"/>
            <a:stretch/>
          </p:blipFill>
          <p:spPr bwMode="auto">
            <a:xfrm>
              <a:off x="1516284" y="2160473"/>
              <a:ext cx="8843966" cy="72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" name="文本框 4"/>
            <p:cNvSpPr txBox="1"/>
            <p:nvPr/>
          </p:nvSpPr>
          <p:spPr>
            <a:xfrm>
              <a:off x="266218" y="2151141"/>
              <a:ext cx="1371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116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66218" y="2520473"/>
              <a:ext cx="13718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Jurkat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" name="直接箭头连接符 7"/>
            <p:cNvCxnSpPr/>
            <p:nvPr/>
          </p:nvCxnSpPr>
          <p:spPr>
            <a:xfrm flipH="1">
              <a:off x="8236250" y="2949923"/>
              <a:ext cx="2124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/>
            <p:cNvSpPr txBox="1"/>
            <p:nvPr/>
          </p:nvSpPr>
          <p:spPr>
            <a:xfrm>
              <a:off x="8505129" y="2938349"/>
              <a:ext cx="1693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ward prim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箭头连接符 10"/>
            <p:cNvCxnSpPr/>
            <p:nvPr/>
          </p:nvCxnSpPr>
          <p:spPr>
            <a:xfrm>
              <a:off x="1516284" y="2081091"/>
              <a:ext cx="229178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1826227" y="1677856"/>
              <a:ext cx="23737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verse primer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4317356" y="2081091"/>
              <a:ext cx="234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/>
          </p:nvSpPr>
          <p:spPr>
            <a:xfrm>
              <a:off x="4317356" y="1677856"/>
              <a:ext cx="237371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文本框 16"/>
          <p:cNvSpPr txBox="1"/>
          <p:nvPr/>
        </p:nvSpPr>
        <p:spPr>
          <a:xfrm>
            <a:off x="648183" y="3122489"/>
            <a:ext cx="103437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equence alignment between bisulfite-Sanger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sequencing results of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verted HCT116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rkat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Vector NTI Advance 11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4810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95</Words>
  <Application>Microsoft Office PowerPoint</Application>
  <PresentationFormat>Widescreen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gd</dc:creator>
  <cp:lastModifiedBy>Naimeng Liu</cp:lastModifiedBy>
  <cp:revision>11</cp:revision>
  <dcterms:created xsi:type="dcterms:W3CDTF">2020-12-13T23:58:34Z</dcterms:created>
  <dcterms:modified xsi:type="dcterms:W3CDTF">2021-04-19T13:24:48Z</dcterms:modified>
</cp:coreProperties>
</file>